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92" r:id="rId2"/>
    <p:sldId id="273" r:id="rId3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72" userDrawn="1">
          <p15:clr>
            <a:srgbClr val="A4A3A4"/>
          </p15:clr>
        </p15:guide>
        <p15:guide id="2" pos="731" userDrawn="1">
          <p15:clr>
            <a:srgbClr val="A4A3A4"/>
          </p15:clr>
        </p15:guide>
        <p15:guide id="3" orient="horz" pos="285" userDrawn="1">
          <p15:clr>
            <a:srgbClr val="A4A3A4"/>
          </p15:clr>
        </p15:guide>
        <p15:guide id="4" pos="2174" userDrawn="1">
          <p15:clr>
            <a:srgbClr val="A4A3A4"/>
          </p15:clr>
        </p15:guide>
        <p15:guide id="5" pos="36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160" autoAdjust="0"/>
  </p:normalViewPr>
  <p:slideViewPr>
    <p:cSldViewPr snapToGrid="0">
      <p:cViewPr varScale="1">
        <p:scale>
          <a:sx n="61" d="100"/>
          <a:sy n="61" d="100"/>
        </p:scale>
        <p:origin x="1152" y="76"/>
      </p:cViewPr>
      <p:guideLst>
        <p:guide orient="horz" pos="872"/>
        <p:guide pos="731"/>
        <p:guide orient="horz" pos="285"/>
        <p:guide pos="2174"/>
        <p:guide pos="36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205EE4-C052-F74E-87DD-231CC4EDC14E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157162-7BE7-964F-9776-8BE3ECC46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262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279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9899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037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2813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441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128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072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843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888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577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38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79A00-EC2A-9C49-8984-8B40B85AB858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E46B5-AB02-394C-B5C8-76A6D7AB32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848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E9115A0A-E227-A2FB-B256-644E48865C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5415359"/>
              </p:ext>
            </p:extLst>
          </p:nvPr>
        </p:nvGraphicFramePr>
        <p:xfrm>
          <a:off x="902703" y="942002"/>
          <a:ext cx="3751799" cy="4659240"/>
        </p:xfrm>
        <a:graphic>
          <a:graphicData uri="http://schemas.openxmlformats.org/drawingml/2006/table">
            <a:tbl>
              <a:tblPr/>
              <a:tblGrid>
                <a:gridCol w="1730494">
                  <a:extLst>
                    <a:ext uri="{9D8B030D-6E8A-4147-A177-3AD203B41FA5}">
                      <a16:colId xmlns:a16="http://schemas.microsoft.com/office/drawing/2014/main" val="3045924427"/>
                    </a:ext>
                  </a:extLst>
                </a:gridCol>
                <a:gridCol w="508764">
                  <a:extLst>
                    <a:ext uri="{9D8B030D-6E8A-4147-A177-3AD203B41FA5}">
                      <a16:colId xmlns:a16="http://schemas.microsoft.com/office/drawing/2014/main" val="22281209"/>
                    </a:ext>
                  </a:extLst>
                </a:gridCol>
                <a:gridCol w="116878">
                  <a:extLst>
                    <a:ext uri="{9D8B030D-6E8A-4147-A177-3AD203B41FA5}">
                      <a16:colId xmlns:a16="http://schemas.microsoft.com/office/drawing/2014/main" val="4211319231"/>
                    </a:ext>
                  </a:extLst>
                </a:gridCol>
                <a:gridCol w="440012">
                  <a:extLst>
                    <a:ext uri="{9D8B030D-6E8A-4147-A177-3AD203B41FA5}">
                      <a16:colId xmlns:a16="http://schemas.microsoft.com/office/drawing/2014/main" val="458217881"/>
                    </a:ext>
                  </a:extLst>
                </a:gridCol>
                <a:gridCol w="955651">
                  <a:extLst>
                    <a:ext uri="{9D8B030D-6E8A-4147-A177-3AD203B41FA5}">
                      <a16:colId xmlns:a16="http://schemas.microsoft.com/office/drawing/2014/main" val="4045428744"/>
                    </a:ext>
                  </a:extLst>
                </a:gridCol>
              </a:tblGrid>
              <a:tr h="316501">
                <a:tc gridSpan="5">
                  <a:txBody>
                    <a:bodyPr/>
                    <a:lstStyle/>
                    <a:p>
                      <a:pPr algn="l" rtl="0" fontAlgn="ctr">
                        <a:spcAft>
                          <a:spcPts val="600"/>
                        </a:spcAft>
                      </a:pPr>
                      <a:r>
                        <a:rPr lang="en-US" altLang="ja-JP" sz="1200" b="1" dirty="0">
                          <a:latin typeface="Times New Roman"/>
                          <a:ea typeface="ＭＳ Ｐゴシック"/>
                          <a:cs typeface="Times New Roman"/>
                        </a:rPr>
                        <a:t>Supplementary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Table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S1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 Histological index in the liver of the 70% partial hepatectomy and lipopolysaccharide (70%PH/LPS)-treated rats  ​</a:t>
                      </a:r>
                    </a:p>
                  </a:txBody>
                  <a:tcPr marL="0" marR="0" marT="0" marB="720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602054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Yu Gothic" panose="020B0400000000000000" pitchFamily="50" charset="-128"/>
                          <a:ea typeface="Yu Gothic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Averag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SD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P value</a:t>
                      </a:r>
                      <a:r>
                        <a:rPr lang="en-US" sz="1200" b="1" i="1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a</a:t>
                      </a:r>
                      <a:endParaRPr lang="en-US" sz="1200" b="1" i="1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736139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H&amp;E scor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043894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Negative control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8974196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.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004804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＋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OLP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04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7903216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418364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MPO-positive cells/mm</a:t>
                      </a:r>
                      <a:r>
                        <a:rPr lang="en-US" sz="12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2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ja-JP" alt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99027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Negative control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  2.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96145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1.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.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614354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＋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OLP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90.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8.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00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138402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076946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TUNEL-positive cells/mm</a:t>
                      </a:r>
                      <a:r>
                        <a:rPr lang="en-US" sz="1200" b="0" i="1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2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ja-JP" alt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550969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Negative control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908660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.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9.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646687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70%PH/LPS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＋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OLP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32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2983770"/>
                  </a:ext>
                </a:extLst>
              </a:tr>
              <a:tr h="254000">
                <a:tc gridSpan="5">
                  <a:txBody>
                    <a:bodyPr/>
                    <a:lstStyle/>
                    <a:p>
                      <a:pPr marL="0" indent="0" algn="l" rtl="0" fontAlgn="ctr">
                        <a:buFont typeface="Arial" panose="020B0604020202020204" pitchFamily="34" charset="0"/>
                        <a:buNone/>
                      </a:pPr>
                      <a:r>
                        <a:rPr lang="en-US" altLang="ja-JP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 70%PH/LPS-only </a:t>
                      </a:r>
                      <a:r>
                        <a:rPr lang="en-US" altLang="ja-JP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v.s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</a:rPr>
                        <a:t>. 70%PH/LPS+OL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7881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11853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011979F-7DA9-AB84-AFAB-7CA595E5AF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8910868"/>
              </p:ext>
            </p:extLst>
          </p:nvPr>
        </p:nvGraphicFramePr>
        <p:xfrm>
          <a:off x="284464" y="534659"/>
          <a:ext cx="5379736" cy="33925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92042">
                  <a:extLst>
                    <a:ext uri="{9D8B030D-6E8A-4147-A177-3AD203B41FA5}">
                      <a16:colId xmlns:a16="http://schemas.microsoft.com/office/drawing/2014/main" val="1142346599"/>
                    </a:ext>
                  </a:extLst>
                </a:gridCol>
                <a:gridCol w="3106385">
                  <a:extLst>
                    <a:ext uri="{9D8B030D-6E8A-4147-A177-3AD203B41FA5}">
                      <a16:colId xmlns:a16="http://schemas.microsoft.com/office/drawing/2014/main" val="4048188655"/>
                    </a:ext>
                  </a:extLst>
                </a:gridCol>
                <a:gridCol w="724143">
                  <a:extLst>
                    <a:ext uri="{9D8B030D-6E8A-4147-A177-3AD203B41FA5}">
                      <a16:colId xmlns:a16="http://schemas.microsoft.com/office/drawing/2014/main" val="821357238"/>
                    </a:ext>
                  </a:extLst>
                </a:gridCol>
                <a:gridCol w="557166">
                  <a:extLst>
                    <a:ext uri="{9D8B030D-6E8A-4147-A177-3AD203B41FA5}">
                      <a16:colId xmlns:a16="http://schemas.microsoft.com/office/drawing/2014/main" val="136204626"/>
                    </a:ext>
                  </a:extLst>
                </a:gridCol>
              </a:tblGrid>
              <a:tr h="38783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′ → 3′) </a:t>
                      </a:r>
                      <a:endParaRPr kumimoji="1" lang="ja-JP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ength</a:t>
                      </a:r>
                    </a:p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bp)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5000809"/>
                  </a:ext>
                </a:extLst>
              </a:tr>
              <a:tr h="196675">
                <a:tc>
                  <a:txBody>
                    <a:bodyPr/>
                    <a:lstStyle/>
                    <a:p>
                      <a:pPr algn="l" fontAlgn="ctr"/>
                      <a:endParaRPr lang="en-US" sz="1200" b="0" i="1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538496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l-GR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 </a:t>
                      </a:r>
                      <a:endParaRPr lang="el-GR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CAACAAGGAGGAGAAGTTCC 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8600290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GCCTTGTCCCTTGAAGAGA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802793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6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AGAAAAGAGTTGTGCAATGGCA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7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7777809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AGGCAAATTTCCTGGTTATATCC ​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1475538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L1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CCAAGCCACAGGGGCGCCCGT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1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821533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TTGGGGACACCCTTTAGCATC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5730572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OS</a:t>
                      </a:r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CCTGCAGGTCTTCGATG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1671629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GATGCACAACTGGGTGAAC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4386508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lvl="0" indent="0" algn="l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1β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CAGGACTTTAAGGGTTACTTGG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5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4376418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CTTTGTCTTGGAGCTTATTAAA</a:t>
                      </a: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614416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GTTGGAATGGTGACAACATGC 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5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8184229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GGAAGAGCTTCACTCAAAGCTT 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275" marR="5275" marT="527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960462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962C275-B449-8F3F-FE24-2F76578250C3}"/>
              </a:ext>
            </a:extLst>
          </p:cNvPr>
          <p:cNvSpPr txBox="1"/>
          <p:nvPr/>
        </p:nvSpPr>
        <p:spPr>
          <a:xfrm>
            <a:off x="284464" y="234443"/>
            <a:ext cx="5570236" cy="248588"/>
          </a:xfrm>
          <a:prstGeom prst="rect">
            <a:avLst/>
          </a:prstGeom>
          <a:noFill/>
        </p:spPr>
        <p:txBody>
          <a:bodyPr wrap="square" lIns="63305" tIns="31652" rIns="63305" bIns="31652" anchor="t">
            <a:spAutoFit/>
          </a:bodyPr>
          <a:lstStyle/>
          <a:p>
            <a:r>
              <a:rPr lang="en-US" altLang="ja-JP" sz="1200" b="1" dirty="0">
                <a:latin typeface="Times New Roman"/>
                <a:ea typeface="ＭＳ Ｐゴシック"/>
                <a:cs typeface="Times New Roman"/>
              </a:rPr>
              <a:t>Supplementary Table S2 Primers used for RT-PCR</a:t>
            </a:r>
            <a:r>
              <a:rPr lang="ja-JP" altLang="en-US" sz="1200" b="1" dirty="0">
                <a:latin typeface="Times New Roman"/>
                <a:ea typeface="ＭＳ Ｐゴシック"/>
                <a:cs typeface="Times New Roman"/>
              </a:rPr>
              <a:t> </a:t>
            </a:r>
            <a:r>
              <a:rPr lang="en-US" altLang="ja-JP" sz="1200" b="1" dirty="0">
                <a:latin typeface="Times New Roman"/>
                <a:ea typeface="ＭＳ Ｐゴシック"/>
                <a:cs typeface="Times New Roman"/>
              </a:rPr>
              <a:t>to detect mRNA</a:t>
            </a:r>
            <a:endParaRPr lang="ja-JP" altLang="en-US" sz="1200" b="1" dirty="0">
              <a:latin typeface="Times New Roman"/>
              <a:ea typeface="ＭＳ Ｐゴシック"/>
              <a:cs typeface="Times New Roman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DDBCED-9901-1260-2947-A4D1D7596793}"/>
              </a:ext>
            </a:extLst>
          </p:cNvPr>
          <p:cNvSpPr txBox="1"/>
          <p:nvPr/>
        </p:nvSpPr>
        <p:spPr>
          <a:xfrm>
            <a:off x="236549" y="3973620"/>
            <a:ext cx="54755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RT-PCR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reverse transcription-polymerase chain reaction, </a:t>
            </a:r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bp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base pairs, </a:t>
            </a:r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EF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elongation factor 1</a:t>
            </a:r>
            <a:r>
              <a:rPr lang="el-GR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TNF-</a:t>
            </a:r>
            <a:r>
              <a:rPr lang="el-GR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 tumor necrosis factor </a:t>
            </a:r>
            <a:r>
              <a:rPr lang="el-GR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IL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 interleukin, </a:t>
            </a:r>
            <a:r>
              <a:rPr lang="en-US" altLang="ja-JP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CXCL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 C-X-C motif chemokine ligand, </a:t>
            </a:r>
            <a:r>
              <a:rPr lang="en-US" altLang="ja-JP" sz="1200" i="1" err="1">
                <a:latin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 inducible nitric oxide synthase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8304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3</TotalTime>
  <Words>231</Words>
  <Application>Microsoft Office PowerPoint</Application>
  <PresentationFormat>A4 210 x 297 mm</PresentationFormat>
  <Paragraphs>9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ＭＳ Ｐゴシック</vt:lpstr>
      <vt:lpstr>Yu Gothic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1</dc:creator>
  <cp:lastModifiedBy>哲矢 奥山</cp:lastModifiedBy>
  <cp:revision>3</cp:revision>
  <cp:lastPrinted>2020-09-21T00:12:44Z</cp:lastPrinted>
  <dcterms:created xsi:type="dcterms:W3CDTF">2020-06-24T00:33:59Z</dcterms:created>
  <dcterms:modified xsi:type="dcterms:W3CDTF">2024-04-15T12:34:38Z</dcterms:modified>
</cp:coreProperties>
</file>